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386" r:id="rId2"/>
    <p:sldId id="387" r:id="rId3"/>
    <p:sldId id="388" r:id="rId4"/>
    <p:sldId id="389" r:id="rId5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既定のセクション" id="{39D0A97F-04C0-4BB4-BF01-76C3C857872B}">
          <p14:sldIdLst>
            <p14:sldId id="386"/>
            <p14:sldId id="387"/>
            <p14:sldId id="388"/>
            <p14:sldId id="389"/>
          </p14:sldIdLst>
        </p14:section>
      </p14:section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5758FB7-9AC5-4552-8A53-C91805E547FA}" styleName="テーマ スタイル 1 - アクセント 5">
    <a:tblBg>
      <a:fillRef idx="2">
        <a:schemeClr val="accent5"/>
      </a:fillRef>
      <a:effectRef idx="1">
        <a:schemeClr val="accent5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Ref idx="1">
              <a:schemeClr val="accent5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  <a:fill>
          <a:solidFill>
            <a:schemeClr val="accent5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5"/>
            </a:lnRef>
          </a:left>
          <a:right>
            <a:lnRef idx="2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2">
              <a:schemeClr val="accent5"/>
            </a:lnRef>
          </a:top>
          <a:bottom>
            <a:lnRef idx="2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firstRow>
  </a:tblStyle>
  <a:tblStyle styleId="{08FB837D-C827-4EFA-A057-4D05807E0F7C}" styleName="テーマ スタイル 1 - アクセント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711" autoAdjust="0"/>
    <p:restoredTop sz="93190" autoAdjust="0"/>
  </p:normalViewPr>
  <p:slideViewPr>
    <p:cSldViewPr>
      <p:cViewPr>
        <p:scale>
          <a:sx n="80" d="100"/>
          <a:sy n="80" d="100"/>
        </p:scale>
        <p:origin x="-1674" y="-18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9E97B0D-033A-4428-BFA9-487D1C24917E}" type="datetimeFigureOut">
              <a:rPr kumimoji="1" lang="ja-JP" altLang="en-US" smtClean="0"/>
              <a:pPr/>
              <a:t>2020/6/1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6EF6541-CCDB-43FB-8A30-23DF13B897B7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95331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FBD70D-0DEE-4120-9CD0-26231331C1CD}" type="datetimeFigureOut">
              <a:rPr kumimoji="1" lang="ja-JP" altLang="en-US" smtClean="0"/>
              <a:pPr/>
              <a:t>2020/6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70865-E5DE-4190-9563-D2490D60B2E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13138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FBD70D-0DEE-4120-9CD0-26231331C1CD}" type="datetimeFigureOut">
              <a:rPr kumimoji="1" lang="ja-JP" altLang="en-US" smtClean="0"/>
              <a:pPr/>
              <a:t>2020/6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70865-E5DE-4190-9563-D2490D60B2E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27970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FBD70D-0DEE-4120-9CD0-26231331C1CD}" type="datetimeFigureOut">
              <a:rPr kumimoji="1" lang="ja-JP" altLang="en-US" smtClean="0"/>
              <a:pPr/>
              <a:t>2020/6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70865-E5DE-4190-9563-D2490D60B2E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0484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FBD70D-0DEE-4120-9CD0-26231331C1CD}" type="datetimeFigureOut">
              <a:rPr kumimoji="1" lang="ja-JP" altLang="en-US" smtClean="0"/>
              <a:pPr/>
              <a:t>2020/6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70865-E5DE-4190-9563-D2490D60B2E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70476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1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FBD70D-0DEE-4120-9CD0-26231331C1CD}" type="datetimeFigureOut">
              <a:rPr kumimoji="1" lang="ja-JP" altLang="en-US" smtClean="0"/>
              <a:pPr/>
              <a:t>2020/6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70865-E5DE-4190-9563-D2490D60B2E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35975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FBD70D-0DEE-4120-9CD0-26231331C1CD}" type="datetimeFigureOut">
              <a:rPr kumimoji="1" lang="ja-JP" altLang="en-US" smtClean="0"/>
              <a:pPr/>
              <a:t>2020/6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70865-E5DE-4190-9563-D2490D60B2E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11542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FBD70D-0DEE-4120-9CD0-26231331C1CD}" type="datetimeFigureOut">
              <a:rPr kumimoji="1" lang="ja-JP" altLang="en-US" smtClean="0"/>
              <a:pPr/>
              <a:t>2020/6/1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70865-E5DE-4190-9563-D2490D60B2E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31883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FBD70D-0DEE-4120-9CD0-26231331C1CD}" type="datetimeFigureOut">
              <a:rPr kumimoji="1" lang="ja-JP" altLang="en-US" smtClean="0"/>
              <a:pPr/>
              <a:t>2020/6/1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70865-E5DE-4190-9563-D2490D60B2E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63430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FBD70D-0DEE-4120-9CD0-26231331C1CD}" type="datetimeFigureOut">
              <a:rPr kumimoji="1" lang="ja-JP" altLang="en-US" smtClean="0"/>
              <a:pPr/>
              <a:t>2020/6/1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70865-E5DE-4190-9563-D2490D60B2E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76419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FBD70D-0DEE-4120-9CD0-26231331C1CD}" type="datetimeFigureOut">
              <a:rPr kumimoji="1" lang="ja-JP" altLang="en-US" smtClean="0"/>
              <a:pPr/>
              <a:t>2020/6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70865-E5DE-4190-9563-D2490D60B2E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72990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FBD70D-0DEE-4120-9CD0-26231331C1CD}" type="datetimeFigureOut">
              <a:rPr kumimoji="1" lang="ja-JP" altLang="en-US" smtClean="0"/>
              <a:pPr/>
              <a:t>2020/6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770865-E5DE-4190-9563-D2490D60B2E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7679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FBD70D-0DEE-4120-9CD0-26231331C1CD}" type="datetimeFigureOut">
              <a:rPr kumimoji="1" lang="ja-JP" altLang="en-US" smtClean="0"/>
              <a:pPr/>
              <a:t>2020/6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770865-E5DE-4190-9563-D2490D60B2E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29022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Fi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91680" y="37310"/>
            <a:ext cx="7416824" cy="684807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テキスト ボックス 3"/>
          <p:cNvSpPr txBox="1"/>
          <p:nvPr/>
        </p:nvSpPr>
        <p:spPr>
          <a:xfrm>
            <a:off x="71366" y="362783"/>
            <a:ext cx="10249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1a-d</a:t>
            </a:r>
            <a:endParaRPr kumimoji="1" lang="en-US" altLang="ja-JP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71366" y="854428"/>
            <a:ext cx="219637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w </a:t>
            </a:r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lot data are shown as </a:t>
            </a:r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-xx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2483768" y="790186"/>
            <a:ext cx="397866" cy="276999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2</a:t>
            </a:r>
            <a:endParaRPr lang="ja-JP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正方形/長方形 8"/>
          <p:cNvSpPr/>
          <p:nvPr/>
        </p:nvSpPr>
        <p:spPr>
          <a:xfrm>
            <a:off x="2483768" y="408383"/>
            <a:ext cx="397866" cy="276999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1</a:t>
            </a:r>
            <a:endParaRPr lang="ja-JP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正方形/長方形 9"/>
          <p:cNvSpPr/>
          <p:nvPr/>
        </p:nvSpPr>
        <p:spPr>
          <a:xfrm>
            <a:off x="2483768" y="1124988"/>
            <a:ext cx="397866" cy="276999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3</a:t>
            </a:r>
            <a:endParaRPr lang="ja-JP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正方形/長方形 10"/>
          <p:cNvSpPr/>
          <p:nvPr/>
        </p:nvSpPr>
        <p:spPr>
          <a:xfrm>
            <a:off x="2506873" y="1848647"/>
            <a:ext cx="397866" cy="276999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5</a:t>
            </a:r>
            <a:endParaRPr lang="ja-JP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正方形/長方形 11"/>
          <p:cNvSpPr/>
          <p:nvPr/>
        </p:nvSpPr>
        <p:spPr>
          <a:xfrm>
            <a:off x="2506873" y="1426954"/>
            <a:ext cx="397866" cy="276999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4</a:t>
            </a:r>
            <a:endParaRPr lang="ja-JP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正方形/長方形 12"/>
          <p:cNvSpPr/>
          <p:nvPr/>
        </p:nvSpPr>
        <p:spPr>
          <a:xfrm>
            <a:off x="2506873" y="2125646"/>
            <a:ext cx="397866" cy="276999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6</a:t>
            </a:r>
            <a:endParaRPr lang="ja-JP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正方形/長方形 13"/>
          <p:cNvSpPr/>
          <p:nvPr/>
        </p:nvSpPr>
        <p:spPr>
          <a:xfrm>
            <a:off x="2483768" y="2761681"/>
            <a:ext cx="397866" cy="276999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8</a:t>
            </a:r>
            <a:endParaRPr lang="ja-JP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正方形/長方形 14"/>
          <p:cNvSpPr/>
          <p:nvPr/>
        </p:nvSpPr>
        <p:spPr>
          <a:xfrm>
            <a:off x="2495612" y="2405344"/>
            <a:ext cx="397866" cy="276999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7</a:t>
            </a:r>
            <a:endParaRPr lang="ja-JP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正方形/長方形 15"/>
          <p:cNvSpPr/>
          <p:nvPr/>
        </p:nvSpPr>
        <p:spPr>
          <a:xfrm>
            <a:off x="2483768" y="3038680"/>
            <a:ext cx="397866" cy="276999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9</a:t>
            </a:r>
            <a:endParaRPr lang="ja-JP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正方形/長方形 16"/>
          <p:cNvSpPr/>
          <p:nvPr/>
        </p:nvSpPr>
        <p:spPr>
          <a:xfrm>
            <a:off x="6257430" y="468545"/>
            <a:ext cx="474810" cy="276999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10</a:t>
            </a:r>
            <a:endParaRPr lang="ja-JP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正方形/長方形 17"/>
          <p:cNvSpPr/>
          <p:nvPr/>
        </p:nvSpPr>
        <p:spPr>
          <a:xfrm>
            <a:off x="6257430" y="790186"/>
            <a:ext cx="469103" cy="276999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11</a:t>
            </a:r>
            <a:endParaRPr lang="ja-JP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正方形/長方形 18"/>
          <p:cNvSpPr/>
          <p:nvPr/>
        </p:nvSpPr>
        <p:spPr>
          <a:xfrm>
            <a:off x="6251723" y="1118853"/>
            <a:ext cx="474810" cy="276999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12</a:t>
            </a:r>
            <a:endParaRPr lang="ja-JP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正方形/長方形 19"/>
          <p:cNvSpPr/>
          <p:nvPr/>
        </p:nvSpPr>
        <p:spPr>
          <a:xfrm>
            <a:off x="6251723" y="1440494"/>
            <a:ext cx="474810" cy="276999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13</a:t>
            </a:r>
            <a:endParaRPr lang="ja-JP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正方形/長方形 20"/>
          <p:cNvSpPr/>
          <p:nvPr/>
        </p:nvSpPr>
        <p:spPr>
          <a:xfrm>
            <a:off x="6214668" y="1814934"/>
            <a:ext cx="474810" cy="276999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15</a:t>
            </a:r>
            <a:endParaRPr lang="ja-JP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正方形/長方形 21"/>
          <p:cNvSpPr/>
          <p:nvPr/>
        </p:nvSpPr>
        <p:spPr>
          <a:xfrm>
            <a:off x="6214668" y="2136575"/>
            <a:ext cx="474810" cy="276999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14</a:t>
            </a:r>
            <a:endParaRPr lang="ja-JP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正方形/長方形 22"/>
          <p:cNvSpPr/>
          <p:nvPr/>
        </p:nvSpPr>
        <p:spPr>
          <a:xfrm>
            <a:off x="6214668" y="2484682"/>
            <a:ext cx="474810" cy="276999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16</a:t>
            </a:r>
            <a:endParaRPr lang="ja-JP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正方形/長方形 23"/>
          <p:cNvSpPr/>
          <p:nvPr/>
        </p:nvSpPr>
        <p:spPr>
          <a:xfrm>
            <a:off x="6214668" y="2806323"/>
            <a:ext cx="474810" cy="276999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17</a:t>
            </a:r>
            <a:endParaRPr lang="ja-JP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正方形/長方形 24"/>
          <p:cNvSpPr/>
          <p:nvPr/>
        </p:nvSpPr>
        <p:spPr>
          <a:xfrm>
            <a:off x="6214668" y="3072679"/>
            <a:ext cx="474810" cy="276999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18</a:t>
            </a:r>
            <a:endParaRPr lang="ja-JP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正方形/長方形 25"/>
          <p:cNvSpPr/>
          <p:nvPr/>
        </p:nvSpPr>
        <p:spPr>
          <a:xfrm>
            <a:off x="2585022" y="3781726"/>
            <a:ext cx="474810" cy="276999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19</a:t>
            </a:r>
            <a:endParaRPr lang="ja-JP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正方形/長方形 26"/>
          <p:cNvSpPr/>
          <p:nvPr/>
        </p:nvSpPr>
        <p:spPr>
          <a:xfrm>
            <a:off x="2585022" y="4103367"/>
            <a:ext cx="474810" cy="276999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20</a:t>
            </a:r>
            <a:endParaRPr lang="ja-JP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正方形/長方形 27"/>
          <p:cNvSpPr/>
          <p:nvPr/>
        </p:nvSpPr>
        <p:spPr>
          <a:xfrm>
            <a:off x="2579315" y="4432034"/>
            <a:ext cx="474810" cy="276999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21</a:t>
            </a:r>
            <a:endParaRPr lang="ja-JP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正方形/長方形 28"/>
          <p:cNvSpPr/>
          <p:nvPr/>
        </p:nvSpPr>
        <p:spPr>
          <a:xfrm>
            <a:off x="2579315" y="4753675"/>
            <a:ext cx="474810" cy="276999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22</a:t>
            </a:r>
            <a:endParaRPr lang="ja-JP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正方形/長方形 29"/>
          <p:cNvSpPr/>
          <p:nvPr/>
        </p:nvSpPr>
        <p:spPr>
          <a:xfrm>
            <a:off x="2542260" y="5128115"/>
            <a:ext cx="474810" cy="276999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23</a:t>
            </a:r>
            <a:endParaRPr lang="ja-JP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正方形/長方形 30"/>
          <p:cNvSpPr/>
          <p:nvPr/>
        </p:nvSpPr>
        <p:spPr>
          <a:xfrm>
            <a:off x="2542260" y="5449756"/>
            <a:ext cx="474810" cy="276999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24</a:t>
            </a:r>
            <a:endParaRPr lang="ja-JP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正方形/長方形 31"/>
          <p:cNvSpPr/>
          <p:nvPr/>
        </p:nvSpPr>
        <p:spPr>
          <a:xfrm>
            <a:off x="2542260" y="5797863"/>
            <a:ext cx="474810" cy="276999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25</a:t>
            </a:r>
            <a:endParaRPr lang="ja-JP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正方形/長方形 32"/>
          <p:cNvSpPr/>
          <p:nvPr/>
        </p:nvSpPr>
        <p:spPr>
          <a:xfrm>
            <a:off x="2542260" y="6119504"/>
            <a:ext cx="474810" cy="276999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26</a:t>
            </a:r>
            <a:endParaRPr lang="ja-JP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正方形/長方形 33"/>
          <p:cNvSpPr/>
          <p:nvPr/>
        </p:nvSpPr>
        <p:spPr>
          <a:xfrm>
            <a:off x="2542260" y="6385860"/>
            <a:ext cx="474810" cy="276999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27</a:t>
            </a:r>
            <a:endParaRPr lang="ja-JP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正方形/長方形 34"/>
          <p:cNvSpPr/>
          <p:nvPr/>
        </p:nvSpPr>
        <p:spPr>
          <a:xfrm>
            <a:off x="6256626" y="3781725"/>
            <a:ext cx="474810" cy="276999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28</a:t>
            </a:r>
            <a:endParaRPr lang="ja-JP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正方形/長方形 35"/>
          <p:cNvSpPr/>
          <p:nvPr/>
        </p:nvSpPr>
        <p:spPr>
          <a:xfrm>
            <a:off x="6256626" y="4155035"/>
            <a:ext cx="474810" cy="276999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29</a:t>
            </a:r>
            <a:endParaRPr lang="ja-JP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正方形/長方形 36"/>
          <p:cNvSpPr/>
          <p:nvPr/>
        </p:nvSpPr>
        <p:spPr>
          <a:xfrm>
            <a:off x="6250919" y="4520153"/>
            <a:ext cx="474810" cy="276999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30</a:t>
            </a:r>
            <a:endParaRPr lang="ja-JP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正方形/長方形 37"/>
          <p:cNvSpPr/>
          <p:nvPr/>
        </p:nvSpPr>
        <p:spPr>
          <a:xfrm>
            <a:off x="6257430" y="4880193"/>
            <a:ext cx="474810" cy="276999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31</a:t>
            </a:r>
            <a:endParaRPr lang="ja-JP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正方形/長方形 38"/>
          <p:cNvSpPr/>
          <p:nvPr/>
        </p:nvSpPr>
        <p:spPr>
          <a:xfrm>
            <a:off x="6244813" y="5239527"/>
            <a:ext cx="474810" cy="276999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32</a:t>
            </a:r>
            <a:endParaRPr lang="ja-JP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正方形/長方形 39"/>
          <p:cNvSpPr/>
          <p:nvPr/>
        </p:nvSpPr>
        <p:spPr>
          <a:xfrm>
            <a:off x="6257430" y="5600273"/>
            <a:ext cx="474810" cy="276999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33</a:t>
            </a:r>
            <a:endParaRPr lang="ja-JP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正方形/長方形 40"/>
          <p:cNvSpPr/>
          <p:nvPr/>
        </p:nvSpPr>
        <p:spPr>
          <a:xfrm>
            <a:off x="6228184" y="5877272"/>
            <a:ext cx="474810" cy="276999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34</a:t>
            </a:r>
            <a:endParaRPr lang="ja-JP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正方形/長方形 41"/>
          <p:cNvSpPr/>
          <p:nvPr/>
        </p:nvSpPr>
        <p:spPr>
          <a:xfrm>
            <a:off x="6213864" y="6248345"/>
            <a:ext cx="474810" cy="276999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35</a:t>
            </a:r>
            <a:endParaRPr lang="ja-JP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正方形/長方形 42"/>
          <p:cNvSpPr/>
          <p:nvPr/>
        </p:nvSpPr>
        <p:spPr>
          <a:xfrm>
            <a:off x="6228184" y="6608385"/>
            <a:ext cx="474810" cy="276999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2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36</a:t>
            </a:r>
            <a:endParaRPr lang="ja-JP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919908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Fi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8280"/>
          <a:stretch/>
        </p:blipFill>
        <p:spPr bwMode="auto">
          <a:xfrm>
            <a:off x="2627784" y="487253"/>
            <a:ext cx="4824536" cy="53900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正方形/長方形 6"/>
          <p:cNvSpPr/>
          <p:nvPr/>
        </p:nvSpPr>
        <p:spPr>
          <a:xfrm>
            <a:off x="4172608" y="1339277"/>
            <a:ext cx="572593" cy="338554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6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37</a:t>
            </a:r>
            <a:endParaRPr lang="ja-JP" altLang="en-US" sz="16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4219504" y="1949694"/>
            <a:ext cx="572593" cy="338554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6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38</a:t>
            </a:r>
            <a:endParaRPr lang="ja-JP" altLang="en-US" sz="16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正方形/長方形 8"/>
          <p:cNvSpPr/>
          <p:nvPr/>
        </p:nvSpPr>
        <p:spPr>
          <a:xfrm>
            <a:off x="4172608" y="2843099"/>
            <a:ext cx="572593" cy="338554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6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39</a:t>
            </a:r>
            <a:endParaRPr lang="ja-JP" altLang="en-US" sz="16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正方形/長方形 9"/>
          <p:cNvSpPr/>
          <p:nvPr/>
        </p:nvSpPr>
        <p:spPr>
          <a:xfrm>
            <a:off x="4219504" y="3575767"/>
            <a:ext cx="572593" cy="338554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6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40</a:t>
            </a:r>
            <a:endParaRPr lang="ja-JP" altLang="en-US" sz="16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正方形/長方形 10"/>
          <p:cNvSpPr/>
          <p:nvPr/>
        </p:nvSpPr>
        <p:spPr>
          <a:xfrm>
            <a:off x="4172607" y="4417566"/>
            <a:ext cx="572593" cy="338554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6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41</a:t>
            </a:r>
            <a:endParaRPr lang="ja-JP" altLang="en-US" sz="16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正方形/長方形 11"/>
          <p:cNvSpPr/>
          <p:nvPr/>
        </p:nvSpPr>
        <p:spPr>
          <a:xfrm>
            <a:off x="4159976" y="4921622"/>
            <a:ext cx="572593" cy="338554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6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42</a:t>
            </a:r>
            <a:endParaRPr lang="ja-JP" altLang="en-US" sz="16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正方形/長方形 12"/>
          <p:cNvSpPr/>
          <p:nvPr/>
        </p:nvSpPr>
        <p:spPr>
          <a:xfrm>
            <a:off x="4159975" y="5526585"/>
            <a:ext cx="572593" cy="338554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6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43</a:t>
            </a:r>
            <a:endParaRPr lang="ja-JP" altLang="en-US" sz="16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215382" y="487253"/>
            <a:ext cx="10249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3a</a:t>
            </a:r>
            <a:endParaRPr kumimoji="1" lang="en-US" altLang="ja-JP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215382" y="978898"/>
            <a:ext cx="219637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w </a:t>
            </a:r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lot data are shown as </a:t>
            </a:r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-xx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798743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Fi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0000" b="53512"/>
          <a:stretch/>
        </p:blipFill>
        <p:spPr bwMode="auto">
          <a:xfrm>
            <a:off x="3491880" y="169011"/>
            <a:ext cx="4660270" cy="60683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正方形/長方形 6"/>
          <p:cNvSpPr/>
          <p:nvPr/>
        </p:nvSpPr>
        <p:spPr>
          <a:xfrm>
            <a:off x="4788026" y="716258"/>
            <a:ext cx="572593" cy="338554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6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44</a:t>
            </a:r>
            <a:endParaRPr lang="ja-JP" altLang="en-US" sz="16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4788025" y="1207212"/>
            <a:ext cx="572593" cy="338554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6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45</a:t>
            </a:r>
            <a:endParaRPr lang="ja-JP" altLang="en-US" sz="16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正方形/長方形 8"/>
          <p:cNvSpPr/>
          <p:nvPr/>
        </p:nvSpPr>
        <p:spPr>
          <a:xfrm>
            <a:off x="4791497" y="1652362"/>
            <a:ext cx="572593" cy="338554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6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46</a:t>
            </a:r>
            <a:endParaRPr lang="ja-JP" altLang="en-US" sz="16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正方形/長方形 9"/>
          <p:cNvSpPr/>
          <p:nvPr/>
        </p:nvSpPr>
        <p:spPr>
          <a:xfrm>
            <a:off x="4788024" y="2082334"/>
            <a:ext cx="572593" cy="338554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6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47</a:t>
            </a:r>
            <a:endParaRPr lang="ja-JP" altLang="en-US" sz="16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正方形/長方形 10"/>
          <p:cNvSpPr/>
          <p:nvPr/>
        </p:nvSpPr>
        <p:spPr>
          <a:xfrm>
            <a:off x="4788024" y="2465936"/>
            <a:ext cx="572593" cy="338554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6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48</a:t>
            </a:r>
            <a:endParaRPr lang="ja-JP" altLang="en-US" sz="16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正方形/長方形 11"/>
          <p:cNvSpPr/>
          <p:nvPr/>
        </p:nvSpPr>
        <p:spPr>
          <a:xfrm>
            <a:off x="4788024" y="2946430"/>
            <a:ext cx="572593" cy="338554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6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49</a:t>
            </a:r>
            <a:endParaRPr lang="ja-JP" altLang="en-US" sz="16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正方形/長方形 12"/>
          <p:cNvSpPr/>
          <p:nvPr/>
        </p:nvSpPr>
        <p:spPr>
          <a:xfrm>
            <a:off x="4788024" y="3358250"/>
            <a:ext cx="572593" cy="338554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6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50</a:t>
            </a:r>
            <a:endParaRPr lang="ja-JP" altLang="en-US" sz="16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正方形/長方形 13"/>
          <p:cNvSpPr/>
          <p:nvPr/>
        </p:nvSpPr>
        <p:spPr>
          <a:xfrm>
            <a:off x="4788024" y="3810526"/>
            <a:ext cx="572593" cy="338554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6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51</a:t>
            </a:r>
            <a:endParaRPr lang="ja-JP" altLang="en-US" sz="16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正方形/長方形 14"/>
          <p:cNvSpPr/>
          <p:nvPr/>
        </p:nvSpPr>
        <p:spPr>
          <a:xfrm>
            <a:off x="4788024" y="4242574"/>
            <a:ext cx="572593" cy="338554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6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52</a:t>
            </a:r>
            <a:endParaRPr lang="ja-JP" altLang="en-US" sz="16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正方形/長方形 15"/>
          <p:cNvSpPr/>
          <p:nvPr/>
        </p:nvSpPr>
        <p:spPr>
          <a:xfrm>
            <a:off x="4788024" y="4725144"/>
            <a:ext cx="572593" cy="338554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6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53</a:t>
            </a:r>
            <a:endParaRPr lang="ja-JP" altLang="en-US" sz="16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正方形/長方形 16"/>
          <p:cNvSpPr/>
          <p:nvPr/>
        </p:nvSpPr>
        <p:spPr>
          <a:xfrm>
            <a:off x="4788024" y="5106670"/>
            <a:ext cx="572593" cy="338554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6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54</a:t>
            </a:r>
            <a:endParaRPr lang="ja-JP" altLang="en-US" sz="16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正方形/長方形 17"/>
          <p:cNvSpPr/>
          <p:nvPr/>
        </p:nvSpPr>
        <p:spPr>
          <a:xfrm>
            <a:off x="4788024" y="5610726"/>
            <a:ext cx="572593" cy="338554"/>
          </a:xfrm>
          <a:prstGeom prst="rect">
            <a:avLst/>
          </a:prstGeom>
          <a:solidFill>
            <a:schemeClr val="bg1">
              <a:alpha val="7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1600" dirty="0" smtClean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-55</a:t>
            </a:r>
            <a:endParaRPr lang="ja-JP" altLang="en-US" sz="16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71366" y="-15655"/>
            <a:ext cx="10249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4a</a:t>
            </a:r>
            <a:endParaRPr kumimoji="1" lang="en-US" altLang="ja-JP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71366" y="372076"/>
            <a:ext cx="38884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w </a:t>
            </a:r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lot data are shown as </a:t>
            </a:r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-xx.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057948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Fi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0000"/>
          <a:stretch/>
        </p:blipFill>
        <p:spPr bwMode="auto">
          <a:xfrm>
            <a:off x="1991362" y="878319"/>
            <a:ext cx="4536504" cy="48896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2" name="グループ化 1"/>
          <p:cNvGrpSpPr/>
          <p:nvPr/>
        </p:nvGrpSpPr>
        <p:grpSpPr>
          <a:xfrm>
            <a:off x="3023665" y="1591730"/>
            <a:ext cx="572594" cy="1383736"/>
            <a:chOff x="1043607" y="1256619"/>
            <a:chExt cx="572594" cy="1383736"/>
          </a:xfrm>
        </p:grpSpPr>
        <p:sp>
          <p:nvSpPr>
            <p:cNvPr id="6" name="正方形/長方形 5"/>
            <p:cNvSpPr/>
            <p:nvPr/>
          </p:nvSpPr>
          <p:spPr>
            <a:xfrm>
              <a:off x="1043608" y="1256619"/>
              <a:ext cx="572593" cy="338554"/>
            </a:xfrm>
            <a:prstGeom prst="rect">
              <a:avLst/>
            </a:prstGeom>
            <a:solidFill>
              <a:schemeClr val="bg1">
                <a:alpha val="70000"/>
              </a:schemeClr>
            </a:solidFill>
          </p:spPr>
          <p:txBody>
            <a:bodyPr wrap="none">
              <a:spAutoFit/>
            </a:bodyPr>
            <a:lstStyle/>
            <a:p>
              <a:r>
                <a:rPr lang="en-US" altLang="ja-JP" sz="1600" dirty="0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-56</a:t>
              </a:r>
              <a:endParaRPr lang="ja-JP" altLang="en-US" sz="16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正方形/長方形 6"/>
            <p:cNvSpPr/>
            <p:nvPr/>
          </p:nvSpPr>
          <p:spPr>
            <a:xfrm>
              <a:off x="1043608" y="1797745"/>
              <a:ext cx="572593" cy="338554"/>
            </a:xfrm>
            <a:prstGeom prst="rect">
              <a:avLst/>
            </a:prstGeom>
            <a:solidFill>
              <a:schemeClr val="bg1">
                <a:alpha val="70000"/>
              </a:schemeClr>
            </a:solidFill>
          </p:spPr>
          <p:txBody>
            <a:bodyPr wrap="none">
              <a:spAutoFit/>
            </a:bodyPr>
            <a:lstStyle/>
            <a:p>
              <a:r>
                <a:rPr lang="en-US" altLang="ja-JP" sz="1600" dirty="0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-57</a:t>
              </a:r>
              <a:endParaRPr lang="ja-JP" altLang="en-US" sz="16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正方形/長方形 7"/>
            <p:cNvSpPr/>
            <p:nvPr/>
          </p:nvSpPr>
          <p:spPr>
            <a:xfrm>
              <a:off x="1043607" y="2301801"/>
              <a:ext cx="572593" cy="338554"/>
            </a:xfrm>
            <a:prstGeom prst="rect">
              <a:avLst/>
            </a:prstGeom>
            <a:solidFill>
              <a:schemeClr val="bg1">
                <a:alpha val="70000"/>
              </a:schemeClr>
            </a:solidFill>
          </p:spPr>
          <p:txBody>
            <a:bodyPr wrap="none">
              <a:spAutoFit/>
            </a:bodyPr>
            <a:lstStyle/>
            <a:p>
              <a:r>
                <a:rPr lang="en-US" altLang="ja-JP" sz="1600" dirty="0" smtClean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-58</a:t>
              </a:r>
              <a:endParaRPr lang="ja-JP" altLang="en-US" sz="16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1" name="テキスト ボックス 10"/>
          <p:cNvSpPr txBox="1"/>
          <p:nvPr/>
        </p:nvSpPr>
        <p:spPr>
          <a:xfrm>
            <a:off x="71366" y="362783"/>
            <a:ext cx="10249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5a</a:t>
            </a:r>
            <a:endParaRPr kumimoji="1" lang="en-US" altLang="ja-JP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1095649" y="395944"/>
            <a:ext cx="44286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w </a:t>
            </a:r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lot data are shown as </a:t>
            </a:r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-xx.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269753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990</TotalTime>
  <Words>100</Words>
  <Application>Microsoft Office PowerPoint</Application>
  <PresentationFormat>画面に合わせる (4:3)</PresentationFormat>
  <Paragraphs>66</Paragraphs>
  <Slides>4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5" baseType="lpstr">
      <vt:lpstr>Office ​​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竹越研/向井研　RC 20150306　0325 菅澤</dc:title>
  <dc:creator>user</dc:creator>
  <cp:lastModifiedBy>takehito</cp:lastModifiedBy>
  <cp:revision>524</cp:revision>
  <dcterms:created xsi:type="dcterms:W3CDTF">2015-03-26T02:04:10Z</dcterms:created>
  <dcterms:modified xsi:type="dcterms:W3CDTF">2020-06-17T08:30:44Z</dcterms:modified>
</cp:coreProperties>
</file>